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7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89336" y="6266559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373216"/>
            <a:ext cx="7657064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uncan and Beach et al (2025) Diabetologia DOI 10.1007/s00125-025-06572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Conceptual model of intersectional stigma and multilevel minority stress and cardiometabolic risk factors and outcomes in sexual and gender minority population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DD7BA0C-9E72-647E-BF55-000C7D20D35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3017" y="1328582"/>
            <a:ext cx="8017966" cy="4188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8</cp:revision>
  <dcterms:created xsi:type="dcterms:W3CDTF">2016-06-15T12:53:43Z</dcterms:created>
  <dcterms:modified xsi:type="dcterms:W3CDTF">2025-10-07T08:31:04Z</dcterms:modified>
</cp:coreProperties>
</file>